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7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D888F522-C1B6-4C39-BB8D-3AE3939F9392}">
          <p14:sldIdLst>
            <p14:sldId id="27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072" userDrawn="1">
          <p15:clr>
            <a:srgbClr val="A4A3A4"/>
          </p15:clr>
        </p15:guide>
        <p15:guide id="2" pos="2064" userDrawn="1">
          <p15:clr>
            <a:srgbClr val="A4A3A4"/>
          </p15:clr>
        </p15:guide>
        <p15:guide id="3" pos="504" userDrawn="1">
          <p15:clr>
            <a:srgbClr val="A4A3A4"/>
          </p15:clr>
        </p15:guide>
        <p15:guide id="4" pos="3696" userDrawn="1">
          <p15:clr>
            <a:srgbClr val="A4A3A4"/>
          </p15:clr>
        </p15:guide>
        <p15:guide id="5" orient="horz" pos="6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C80"/>
    <a:srgbClr val="F7E5E5"/>
    <a:srgbClr val="E6A06F"/>
    <a:srgbClr val="82DBB5"/>
    <a:srgbClr val="F0E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41" autoAdjust="0"/>
    <p:restoredTop sz="90991" autoAdjust="0"/>
  </p:normalViewPr>
  <p:slideViewPr>
    <p:cSldViewPr snapToGrid="0">
      <p:cViewPr varScale="1">
        <p:scale>
          <a:sx n="47" d="100"/>
          <a:sy n="47" d="100"/>
        </p:scale>
        <p:origin x="2490" y="54"/>
      </p:cViewPr>
      <p:guideLst>
        <p:guide orient="horz" pos="3072"/>
        <p:guide pos="2064"/>
        <p:guide pos="504"/>
        <p:guide pos="3696"/>
        <p:guide orient="horz" pos="6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F20DA2-5AB8-445D-B32D-325E6AA94242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44751E-1602-43D1-8E58-2CC253303F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153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44751E-1602-43D1-8E58-2CC253303F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9010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410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7689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0499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2209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7555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351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7137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15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12625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419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677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CA4D4-77F1-460F-BC27-313B40EBECA0}" type="datetimeFigureOut">
              <a:rPr lang="en-US" smtClean="0"/>
              <a:t>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6AE1D-9AB4-4B66-9E70-32B2B7F62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6955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7650EEF8-FC02-44BA-AE6B-3BB754211471}"/>
              </a:ext>
            </a:extLst>
          </p:cNvPr>
          <p:cNvGrpSpPr/>
          <p:nvPr/>
        </p:nvGrpSpPr>
        <p:grpSpPr>
          <a:xfrm>
            <a:off x="800100" y="344688"/>
            <a:ext cx="1990334" cy="2751003"/>
            <a:chOff x="3861263" y="2535922"/>
            <a:chExt cx="1990334" cy="2751003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xmlns="" id="{A3AA4B42-1BE5-4BD7-95DE-7F60375F23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0041"/>
            <a:stretch/>
          </p:blipFill>
          <p:spPr>
            <a:xfrm>
              <a:off x="3879554" y="2535922"/>
              <a:ext cx="1841270" cy="227228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15552075-D5EE-451D-BD28-6990F46A8D5A}"/>
                </a:ext>
              </a:extLst>
            </p:cNvPr>
            <p:cNvSpPr txBox="1"/>
            <p:nvPr/>
          </p:nvSpPr>
          <p:spPr>
            <a:xfrm rot="18988449">
              <a:off x="3861263" y="5025315"/>
              <a:ext cx="114580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hted </a:t>
              </a:r>
              <a:r>
                <a:rPr lang="en-US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t_US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E0842491-C808-463F-BC26-0CE424788F8C}"/>
                </a:ext>
              </a:extLst>
            </p:cNvPr>
            <p:cNvSpPr txBox="1"/>
            <p:nvPr/>
          </p:nvSpPr>
          <p:spPr>
            <a:xfrm rot="18988449">
              <a:off x="4058210" y="5025314"/>
              <a:ext cx="135977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ghted </a:t>
              </a:r>
              <a:r>
                <a:rPr lang="en-US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t_Light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CA26CE00-88B5-45C3-AB1A-E0F4721328F3}"/>
                </a:ext>
              </a:extLst>
            </p:cNvPr>
            <p:cNvSpPr txBox="1"/>
            <p:nvPr/>
          </p:nvSpPr>
          <p:spPr>
            <a:xfrm rot="18988449">
              <a:off x="4701760" y="4906004"/>
              <a:ext cx="1149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ind</a:t>
              </a:r>
              <a:r>
                <a:rPr 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sz="11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rat_US</a:t>
              </a:r>
              <a:endPara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aphicFrame>
        <p:nvGraphicFramePr>
          <p:cNvPr id="11" name="Table 11">
            <a:extLst>
              <a:ext uri="{FF2B5EF4-FFF2-40B4-BE49-F238E27FC236}">
                <a16:creationId xmlns:a16="http://schemas.microsoft.com/office/drawing/2014/main" xmlns="" id="{C6501DCA-25B1-4C86-AF7B-19696D16DF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8163474"/>
              </p:ext>
            </p:extLst>
          </p:nvPr>
        </p:nvGraphicFramePr>
        <p:xfrm>
          <a:off x="2874671" y="657735"/>
          <a:ext cx="3522345" cy="18745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69137">
                  <a:extLst>
                    <a:ext uri="{9D8B030D-6E8A-4147-A177-3AD203B41FA5}">
                      <a16:colId xmlns:a16="http://schemas.microsoft.com/office/drawing/2014/main" xmlns="" val="3568993831"/>
                    </a:ext>
                  </a:extLst>
                </a:gridCol>
                <a:gridCol w="764170">
                  <a:extLst>
                    <a:ext uri="{9D8B030D-6E8A-4147-A177-3AD203B41FA5}">
                      <a16:colId xmlns:a16="http://schemas.microsoft.com/office/drawing/2014/main" xmlns="" val="1795625746"/>
                    </a:ext>
                  </a:extLst>
                </a:gridCol>
                <a:gridCol w="975113">
                  <a:extLst>
                    <a:ext uri="{9D8B030D-6E8A-4147-A177-3AD203B41FA5}">
                      <a16:colId xmlns:a16="http://schemas.microsoft.com/office/drawing/2014/main" xmlns="" val="1733047268"/>
                    </a:ext>
                  </a:extLst>
                </a:gridCol>
                <a:gridCol w="413925">
                  <a:extLst>
                    <a:ext uri="{9D8B030D-6E8A-4147-A177-3AD203B41FA5}">
                      <a16:colId xmlns:a16="http://schemas.microsoft.com/office/drawing/2014/main" xmlns="" val="728172867"/>
                    </a:ext>
                  </a:extLst>
                </a:gridCol>
              </a:tblGrid>
              <a:tr h="282467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Latency (</a:t>
                      </a:r>
                      <a:r>
                        <a:rPr lang="en-US" sz="1100" dirty="0" err="1"/>
                        <a:t>ms</a:t>
                      </a:r>
                      <a:r>
                        <a:rPr lang="en-US" sz="1100" dirty="0"/>
                        <a:t>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Me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Std. Devi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13741277"/>
                  </a:ext>
                </a:extLst>
              </a:tr>
              <a:tr h="39441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Normal sighted </a:t>
                      </a:r>
                      <a:r>
                        <a:rPr lang="en-US" sz="1100" dirty="0" err="1"/>
                        <a:t>rats_Light</a:t>
                      </a:r>
                      <a:r>
                        <a:rPr lang="en-US" sz="1100" dirty="0"/>
                        <a:t> respon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20.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.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918672190"/>
                  </a:ext>
                </a:extLst>
              </a:tr>
              <a:tr h="549357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dirty="0"/>
                        <a:t>Normal sighted </a:t>
                      </a:r>
                      <a:r>
                        <a:rPr lang="en-US" sz="1100" dirty="0" err="1"/>
                        <a:t>rats_US</a:t>
                      </a:r>
                      <a:r>
                        <a:rPr lang="en-US" sz="1100" dirty="0"/>
                        <a:t> response</a:t>
                      </a:r>
                    </a:p>
                    <a:p>
                      <a:pPr algn="ctr"/>
                      <a:endParaRPr lang="en-US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43.8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9.5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858835180"/>
                  </a:ext>
                </a:extLst>
              </a:tr>
              <a:tr h="394410"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RCS blind </a:t>
                      </a:r>
                      <a:r>
                        <a:rPr lang="en-US" sz="1100" dirty="0" err="1"/>
                        <a:t>rats_US</a:t>
                      </a:r>
                      <a:r>
                        <a:rPr lang="en-US" sz="1100" dirty="0"/>
                        <a:t> respon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86.6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8.9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509449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78096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53</TotalTime>
  <Words>37</Words>
  <Application>Microsoft Office PowerPoint</Application>
  <PresentationFormat>A4 纸张(210x297 毫米)</PresentationFormat>
  <Paragraphs>2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ngxi Lu</dc:creator>
  <cp:lastModifiedBy>Xuejun Qian</cp:lastModifiedBy>
  <cp:revision>351</cp:revision>
  <dcterms:created xsi:type="dcterms:W3CDTF">2021-01-23T01:25:23Z</dcterms:created>
  <dcterms:modified xsi:type="dcterms:W3CDTF">2022-01-12T06:19:16Z</dcterms:modified>
</cp:coreProperties>
</file>